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81"/>
  </p:normalViewPr>
  <p:slideViewPr>
    <p:cSldViewPr snapToGrid="0">
      <p:cViewPr varScale="1">
        <p:scale>
          <a:sx n="81" d="100"/>
          <a:sy n="81" d="100"/>
        </p:scale>
        <p:origin x="33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156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574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450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953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763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622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91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7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7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215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892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3B056-0A13-5340-A838-3CFF4F9BFDBA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1252A-F536-1E45-B0BD-D41F0D8FC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219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7F6F38AD-8741-05CF-8626-BA163B7BFB4D}"/>
              </a:ext>
            </a:extLst>
          </p:cNvPr>
          <p:cNvGrpSpPr/>
          <p:nvPr/>
        </p:nvGrpSpPr>
        <p:grpSpPr>
          <a:xfrm>
            <a:off x="2211231" y="-247843"/>
            <a:ext cx="2333698" cy="5069237"/>
            <a:chOff x="231201" y="1167409"/>
            <a:chExt cx="2333698" cy="5069237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1CFA477-EC15-7632-CAFB-ED01A65011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8669" r="70462"/>
            <a:stretch/>
          </p:blipFill>
          <p:spPr>
            <a:xfrm>
              <a:off x="231201" y="2503715"/>
              <a:ext cx="2272393" cy="3732931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603E07A-79B6-D2E9-3F25-70F2AFA018B9}"/>
                </a:ext>
              </a:extLst>
            </p:cNvPr>
            <p:cNvSpPr txBox="1"/>
            <p:nvPr/>
          </p:nvSpPr>
          <p:spPr>
            <a:xfrm rot="18593710">
              <a:off x="855238" y="2119331"/>
              <a:ext cx="1419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A-TgFBXL2 + </a:t>
              </a:r>
              <a:r>
                <a:rPr lang="en-US" sz="1000" b="1" dirty="0" err="1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C03A50F-8D14-0C12-F53F-55B74C47FFF1}"/>
                </a:ext>
              </a:extLst>
            </p:cNvPr>
            <p:cNvSpPr txBox="1"/>
            <p:nvPr/>
          </p:nvSpPr>
          <p:spPr>
            <a:xfrm rot="18593710">
              <a:off x="1143497" y="1982924"/>
              <a:ext cx="1775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A-TgFBXL2 + </a:t>
              </a:r>
              <a:r>
                <a:rPr lang="en-US" sz="10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3K9a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18CFF01-832F-931D-155C-D23209517B30}"/>
                </a:ext>
              </a:extLst>
            </p:cNvPr>
            <p:cNvSpPr txBox="1"/>
            <p:nvPr/>
          </p:nvSpPr>
          <p:spPr>
            <a:xfrm rot="18593710">
              <a:off x="1525258" y="1960829"/>
              <a:ext cx="1833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ntagged Parental + </a:t>
              </a:r>
              <a:r>
                <a:rPr lang="en-US" sz="1000" b="1" dirty="0" err="1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28E5E61-862A-D7A3-C7CF-011ADB49ADBC}"/>
                </a:ext>
              </a:extLst>
            </p:cNvPr>
            <p:cNvSpPr txBox="1"/>
            <p:nvPr/>
          </p:nvSpPr>
          <p:spPr>
            <a:xfrm rot="18593710">
              <a:off x="426206" y="2119330"/>
              <a:ext cx="1419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</a:p>
          </p:txBody>
        </p: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18113AFA-6616-E1CF-B490-0B7B479246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2080" y="4380522"/>
            <a:ext cx="4572000" cy="188025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A6E458F-621E-4E0C-795F-F55108475D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2080" y="6295654"/>
            <a:ext cx="4572000" cy="188026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C36B6C4-9F9E-4BCF-227C-015FBC6B50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2080" y="10232910"/>
            <a:ext cx="4572000" cy="188026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CC09D93-65F6-D3CC-D01E-9D7D340DA7AE}"/>
              </a:ext>
            </a:extLst>
          </p:cNvPr>
          <p:cNvSpPr txBox="1"/>
          <p:nvPr/>
        </p:nvSpPr>
        <p:spPr>
          <a:xfrm>
            <a:off x="57853" y="10189200"/>
            <a:ext cx="18330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ntagged Parental + </a:t>
            </a:r>
            <a:r>
              <a:rPr lang="en-US" sz="1000" b="1" dirty="0" err="1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AFF17F2-3C8C-B8BA-28B3-9867725269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2080" y="8302015"/>
            <a:ext cx="4572000" cy="188026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EC4A5B7-E87E-AD08-7127-93EB81C29170}"/>
              </a:ext>
            </a:extLst>
          </p:cNvPr>
          <p:cNvSpPr txBox="1"/>
          <p:nvPr/>
        </p:nvSpPr>
        <p:spPr>
          <a:xfrm>
            <a:off x="264446" y="6292584"/>
            <a:ext cx="1419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TgFBXL2 + </a:t>
            </a:r>
            <a:r>
              <a:rPr lang="en-US" sz="1000" b="1" dirty="0" err="1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717E1E-DFDA-AB43-70C9-4902E85CD3BC}"/>
              </a:ext>
            </a:extLst>
          </p:cNvPr>
          <p:cNvSpPr txBox="1"/>
          <p:nvPr/>
        </p:nvSpPr>
        <p:spPr>
          <a:xfrm>
            <a:off x="86652" y="8249172"/>
            <a:ext cx="1775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TgFBXL2 + </a:t>
            </a:r>
            <a:r>
              <a:rPr lang="en-US" sz="1000" b="1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3K9a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CD64742-A739-9A05-A542-EE5BAD2D55A8}"/>
              </a:ext>
            </a:extLst>
          </p:cNvPr>
          <p:cNvSpPr txBox="1"/>
          <p:nvPr/>
        </p:nvSpPr>
        <p:spPr>
          <a:xfrm>
            <a:off x="264446" y="4345362"/>
            <a:ext cx="1419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1368726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2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 Blader</dc:creator>
  <cp:lastModifiedBy>Ira Blader</cp:lastModifiedBy>
  <cp:revision>2</cp:revision>
  <dcterms:created xsi:type="dcterms:W3CDTF">2023-12-11T17:28:18Z</dcterms:created>
  <dcterms:modified xsi:type="dcterms:W3CDTF">2023-12-12T14:32:44Z</dcterms:modified>
</cp:coreProperties>
</file>